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553BD9E-EC56-46BC-A935-FEE6743391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718EAF5-8E35-4B18-BD82-32949CE6CB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BA44E23-01B2-4116-A0A3-E4E586A52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2504348-E300-4E5E-8929-84E9334C8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4FA7263-7A5F-4EA5-B139-38D0FB768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477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6939B6A-10DA-4EB6-A374-8A6F54DB90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1CFD7A3-9988-49C2-A47C-CB5D661EFB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28997A5-850B-4BF8-9AB3-10EA71969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E78797F-8A3A-4C61-B7C6-610376193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7871060-1E4C-4479-836C-7067BBDBC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88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F720570-8AC6-4928-9A10-6765DF7B18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1779C5B-DDAA-499E-9BE0-08F8363A34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4C05827-EB47-40B6-9D28-931BF6A53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6736637-DEAF-4575-BED3-8A58FCB17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C0756E4-D44B-45CC-A803-A8177D443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186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6D609A-89EC-44E7-B482-942D048063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31A51B7-A100-4CF2-908E-9E62DDAF8E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F6D9C2-6FF5-4F1D-A96B-EFA405AE8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3C4B003-33A9-42FC-A544-4429240DB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96B7660-7082-432A-AE16-7988E889C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56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84FE18-C074-458B-A50D-00C3ECE5B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4AF0D6B-DC63-48AC-9C0F-E5D0F07AA3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115C3B3-C77F-4F66-A3F3-A5EFD7760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C7E6C4-C7C5-4E6F-9BAB-AA6C9CC08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3366C5B-8C92-4BF1-A233-8D8D53EF2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216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8411E20-9F37-4F70-ADE6-7DC061169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2C94084-7CA4-40AA-98FC-1A2FAE19C6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AF50FC0-967B-4038-89E5-006DDFE086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BCD848E-3684-44A6-A7F2-93F49F53B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31E780C-810F-43D6-ADEB-1C93AE17E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27EC6F3-E0CF-4074-9090-B7796A3F8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1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3029F6F-5FB1-4842-97F5-EB5FDA011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B112A85-AFC9-4DFC-9DB3-3ECBE2FD15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9700A43-6232-4DE8-BAEB-0E6F3B3F06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94C1B27-C7AC-458D-8CF1-023A747693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4264597-9D08-40EF-8131-46A94A6AEC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97601F2-705F-44C3-A6EE-30BD92E29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DD6FAE7-1CCA-4452-B362-DF696FF2D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B191F18-F5F7-45FE-B191-4177FD2D0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41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353876-5DE1-4193-836A-15A6A2B172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725C059-9F7C-45E9-9B64-8C5166FA6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C26001B-FA5F-4E5F-8FEB-9170707D2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21D775A-0007-4F7A-9FFB-A2839F0F4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176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BACF219-ADBD-4654-A649-BF74566A1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B555B2D2-EBDF-466E-B26C-42DC93965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7C3C27B-AABA-4628-A5B2-776EE5901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159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9BD6DBD-036A-4FCF-A9CD-65C02EF6DD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8D2B707-6C39-4B18-8973-B208F752C5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E1E87D9-0AC0-4045-9E0E-C6B500BD98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57DF84C-4196-45F2-9DB7-D8129B924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A032C9C-AE4D-4409-BBB7-A1E441B6A9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ADCE944-9DC3-4603-BB84-AC98E3536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992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DE775A9-F463-43A8-BD43-8A91DC46F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5402BD2-F8AB-432D-BA4A-A89FE6BC9A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5313290-8B13-4406-8886-D6E863B80B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4F5D923-9EF8-4ED1-987F-D97880C6B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8790A6C-A2E1-4AD8-BA8D-216011744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545902B-E62A-4463-9C31-6523EF80F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998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22E062E-0485-49A2-9FD2-39A5628937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897B2D4-1DFE-4CBF-8DAA-1EA5F196CF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2BBD780-7B79-4D86-ADCB-56A0A79267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1D7316-3D4F-45DB-BCE3-EC113C558375}" type="datetimeFigureOut">
              <a:rPr lang="en-US" smtClean="0"/>
              <a:t>12/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A0766ED-B48C-4C61-AB44-22CB993C00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CF9AF28-3225-445B-8F61-BC98AB809B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86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o 11">
            <a:extLst>
              <a:ext uri="{FF2B5EF4-FFF2-40B4-BE49-F238E27FC236}">
                <a16:creationId xmlns:a16="http://schemas.microsoft.com/office/drawing/2014/main" id="{F39EA400-14E3-4EDE-BBA8-238B6919CFE8}"/>
              </a:ext>
            </a:extLst>
          </p:cNvPr>
          <p:cNvGrpSpPr/>
          <p:nvPr/>
        </p:nvGrpSpPr>
        <p:grpSpPr>
          <a:xfrm>
            <a:off x="1929050" y="393231"/>
            <a:ext cx="8333901" cy="6324748"/>
            <a:chOff x="1744951" y="1692466"/>
            <a:chExt cx="5692169" cy="4751877"/>
          </a:xfrm>
        </p:grpSpPr>
        <p:pic>
          <p:nvPicPr>
            <p:cNvPr id="13" name="Immagine 12" descr="LEfSe_family_dotplot.pdf - Adobe Acrobat Reader DC">
              <a:extLst>
                <a:ext uri="{FF2B5EF4-FFF2-40B4-BE49-F238E27FC236}">
                  <a16:creationId xmlns:a16="http://schemas.microsoft.com/office/drawing/2014/main" id="{17A776AC-D9ED-4188-B988-F50A5865EF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93" t="23015" r="39208" b="3499"/>
            <a:stretch/>
          </p:blipFill>
          <p:spPr>
            <a:xfrm>
              <a:off x="2865120" y="1692466"/>
              <a:ext cx="4572000" cy="4751877"/>
            </a:xfrm>
            <a:prstGeom prst="rect">
              <a:avLst/>
            </a:prstGeom>
          </p:spPr>
        </p:pic>
        <p:pic>
          <p:nvPicPr>
            <p:cNvPr id="14" name="Immagine 13" descr="bar_graph_4.pdf - Adobe Acrobat Reader DC">
              <a:extLst>
                <a:ext uri="{FF2B5EF4-FFF2-40B4-BE49-F238E27FC236}">
                  <a16:creationId xmlns:a16="http://schemas.microsoft.com/office/drawing/2014/main" id="{D6B9EA68-2D72-426B-8FDE-E24F8CAADA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214" t="20444" r="73657" b="6467"/>
            <a:stretch/>
          </p:blipFill>
          <p:spPr>
            <a:xfrm>
              <a:off x="1744951" y="2058534"/>
              <a:ext cx="1119635" cy="3578319"/>
            </a:xfrm>
            <a:prstGeom prst="rect">
              <a:avLst/>
            </a:prstGeom>
          </p:spPr>
        </p:pic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D36F193A-8752-4886-8CE7-E0A32B9827D6}"/>
              </a:ext>
            </a:extLst>
          </p:cNvPr>
          <p:cNvSpPr txBox="1"/>
          <p:nvPr/>
        </p:nvSpPr>
        <p:spPr>
          <a:xfrm>
            <a:off x="357051" y="27577"/>
            <a:ext cx="114853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upplementary material 3:LDA scores of </a:t>
            </a:r>
            <a:r>
              <a:rPr lang="en-US" sz="1600" dirty="0" err="1"/>
              <a:t>LEfSe</a:t>
            </a:r>
            <a:r>
              <a:rPr lang="en-US" sz="1600" dirty="0"/>
              <a:t> comparison analysis between </a:t>
            </a:r>
            <a:r>
              <a:rPr lang="en-US" sz="1600" dirty="0" err="1"/>
              <a:t>faecal</a:t>
            </a:r>
            <a:r>
              <a:rPr lang="en-US" sz="1600"/>
              <a:t>, drinking water </a:t>
            </a:r>
            <a:r>
              <a:rPr lang="en-US" sz="1600" dirty="0"/>
              <a:t>and biofilm samples. Red and shading depicts bacterial taxa significantly higher in a given sample type.</a:t>
            </a:r>
          </a:p>
        </p:txBody>
      </p:sp>
    </p:spTree>
    <p:extLst>
      <p:ext uri="{BB962C8B-B14F-4D97-AF65-F5344CB8AC3E}">
        <p14:creationId xmlns:p14="http://schemas.microsoft.com/office/powerpoint/2010/main" val="10889873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Laconi</dc:creator>
  <cp:lastModifiedBy>Andrea Laconi</cp:lastModifiedBy>
  <cp:revision>9</cp:revision>
  <dcterms:created xsi:type="dcterms:W3CDTF">2024-02-22T15:09:20Z</dcterms:created>
  <dcterms:modified xsi:type="dcterms:W3CDTF">2024-12-05T13:53:39Z</dcterms:modified>
</cp:coreProperties>
</file>